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24" r:id="rId2"/>
  </p:sldIdLst>
  <p:sldSz cx="10287000" cy="6858000" type="35mm"/>
  <p:notesSz cx="6805613" cy="99393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981">
          <p15:clr>
            <a:srgbClr val="A4A3A4"/>
          </p15:clr>
        </p15:guide>
        <p15:guide id="2" pos="609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00CC"/>
    <a:srgbClr val="EAEAEA"/>
    <a:srgbClr val="D7792C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F2DE63D5-997A-4646-A377-4702673A728D}" styleName="淡色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72" autoAdjust="0"/>
    <p:restoredTop sz="91348" autoAdjust="0"/>
  </p:normalViewPr>
  <p:slideViewPr>
    <p:cSldViewPr>
      <p:cViewPr>
        <p:scale>
          <a:sx n="70" d="100"/>
          <a:sy n="70" d="100"/>
        </p:scale>
        <p:origin x="-540" y="-552"/>
      </p:cViewPr>
      <p:guideLst>
        <p:guide orient="horz" pos="981"/>
        <p:guide pos="609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5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3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4450" y="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08D3D4F2-F19B-48B3-8455-13D2547BDE7B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6554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40863"/>
            <a:ext cx="2949575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4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4450" y="9440863"/>
            <a:ext cx="2949575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89E46D3A-56EC-421A-8A11-6A21FE30D27C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66394972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445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fld id="{A02D4FD3-2E6E-4464-B901-18CBEA3BA936}" type="datetimeFigureOut">
              <a:rPr lang="ja-JP" altLang="en-US"/>
              <a:pPr>
                <a:defRPr/>
              </a:pPr>
              <a:t>2014/8/30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08013" y="746125"/>
            <a:ext cx="5589587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3537" cy="4471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 smtClean="0"/>
              <a:t>マスター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445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fld id="{42A85478-476D-4216-91F0-4AA3CA62082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9215979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217" name="Rectangle 2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</p:sp>
      <p:sp>
        <p:nvSpPr>
          <p:cNvPr id="137218" name="Rectangle 3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ja-JP">
                <a:latin typeface="Calibri" charset="0"/>
                <a:ea typeface="ＭＳ Ｐゴシック" charset="0"/>
              </a:rPr>
              <a:t>Patient 1</a:t>
            </a:r>
          </a:p>
        </p:txBody>
      </p:sp>
    </p:spTree>
    <p:extLst>
      <p:ext uri="{BB962C8B-B14F-4D97-AF65-F5344CB8AC3E}">
        <p14:creationId xmlns:p14="http://schemas.microsoft.com/office/powerpoint/2010/main" val="16042764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5"/>
            <a:ext cx="8743950" cy="14700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DB39CD-679A-435E-9995-A4BCD816551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9C761B0-80D4-4A61-9E23-50E98F6D791E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8"/>
            <a:ext cx="2314575" cy="584993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274638"/>
            <a:ext cx="6791325" cy="584993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44023CA-B3F7-4A7D-B2C0-1B63A9442C67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8BAC86F-BFBD-4852-83ED-E1F61804133E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800" y="4406900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800" y="2906713"/>
            <a:ext cx="874395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E6F186-76B6-48BD-BD6E-41BF97D720DC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1600200"/>
            <a:ext cx="4552950" cy="45243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219700" y="1600200"/>
            <a:ext cx="4552950" cy="45243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718135E-828B-4BCC-8B2C-4E8A8A5656A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01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01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6050" y="1535113"/>
            <a:ext cx="454660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6050" y="2174875"/>
            <a:ext cx="454660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57A5CB-A5C3-4596-8C5B-F598EB96935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DE9A26-DF7C-4583-89D3-C084093E7199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153FEE9-711C-42AF-8940-6D793EE31D0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0" y="273050"/>
            <a:ext cx="3384550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2725" y="273050"/>
            <a:ext cx="5749925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0" y="1435100"/>
            <a:ext cx="3384550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E4210C3-5558-466E-9017-E8B351F9803C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125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125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125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F2D7A19-1204-460C-AAD5-E26AB1E7540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274638"/>
            <a:ext cx="92583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1600200"/>
            <a:ext cx="9258300" cy="4524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6246813"/>
            <a:ext cx="2400300" cy="47625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514725" y="6246813"/>
            <a:ext cx="3257550" cy="47625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7372350" y="6246813"/>
            <a:ext cx="2400300" cy="47625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7A04871F-6FD9-4557-87BE-FA0BD260E7C9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9" r:id="rId1"/>
    <p:sldLayoutId id="2147483668" r:id="rId2"/>
    <p:sldLayoutId id="2147483667" r:id="rId3"/>
    <p:sldLayoutId id="2147483666" r:id="rId4"/>
    <p:sldLayoutId id="2147483665" r:id="rId5"/>
    <p:sldLayoutId id="2147483664" r:id="rId6"/>
    <p:sldLayoutId id="2147483663" r:id="rId7"/>
    <p:sldLayoutId id="2147483662" r:id="rId8"/>
    <p:sldLayoutId id="2147483661" r:id="rId9"/>
    <p:sldLayoutId id="2147483660" r:id="rId10"/>
    <p:sldLayoutId id="2147483659" r:id="rId11"/>
  </p:sldLayoutIdLst>
  <p:txStyles>
    <p:titleStyle>
      <a:lvl1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+mj-lt"/>
          <a:ea typeface="+mj-ea"/>
          <a:cs typeface="+mj-cs"/>
        </a:defRPr>
      </a:lvl1pPr>
      <a:lvl2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2pPr>
      <a:lvl3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3pPr>
      <a:lvl4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4pPr>
      <a:lvl5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5pPr>
      <a:lvl6pPr marL="457200" algn="ctr" defTabSz="912813" rtl="0" fontAlgn="base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6pPr>
      <a:lvl7pPr marL="914400" algn="ctr" defTabSz="912813" rtl="0" fontAlgn="base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7pPr>
      <a:lvl8pPr marL="1371600" algn="ctr" defTabSz="912813" rtl="0" fontAlgn="base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8pPr>
      <a:lvl9pPr marL="1828800" algn="ctr" defTabSz="912813" rtl="0" fontAlgn="base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9pPr>
    </p:titleStyle>
    <p:bodyStyle>
      <a:lvl1pPr marL="342900" indent="-342900" algn="l" defTabSz="912813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4163" algn="l" defTabSz="912813" rtl="0" eaLnBrk="0" fontAlgn="base" hangingPunct="0">
        <a:spcBef>
          <a:spcPct val="20000"/>
        </a:spcBef>
        <a:spcAft>
          <a:spcPct val="0"/>
        </a:spcAft>
        <a:buChar char="–"/>
        <a:defRPr kumimoji="1" sz="2700">
          <a:solidFill>
            <a:schemeClr val="tx1"/>
          </a:solidFill>
          <a:latin typeface="+mn-lt"/>
          <a:ea typeface="+mn-ea"/>
        </a:defRPr>
      </a:lvl2pPr>
      <a:lvl3pPr marL="1143000" indent="-230188" algn="l" defTabSz="912813" rtl="0" eaLnBrk="0" fontAlgn="base" hangingPunct="0">
        <a:spcBef>
          <a:spcPct val="20000"/>
        </a:spcBef>
        <a:spcAft>
          <a:spcPct val="0"/>
        </a:spcAft>
        <a:buChar char="•"/>
        <a:defRPr kumimoji="1" sz="2500">
          <a:solidFill>
            <a:schemeClr val="tx1"/>
          </a:solidFill>
          <a:latin typeface="+mn-lt"/>
          <a:ea typeface="+mn-ea"/>
        </a:defRPr>
      </a:lvl3pPr>
      <a:lvl4pPr marL="1601788" indent="-230188" algn="l" defTabSz="912813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5813" indent="-227013" algn="l" defTabSz="912813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3013" indent="-227013" algn="l" defTabSz="912813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0213" indent="-227013" algn="l" defTabSz="912813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7413" indent="-227013" algn="l" defTabSz="912813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4613" indent="-227013" algn="l" defTabSz="912813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4004" name="Group 10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4674257"/>
              </p:ext>
            </p:extLst>
          </p:nvPr>
        </p:nvGraphicFramePr>
        <p:xfrm>
          <a:off x="390525" y="476250"/>
          <a:ext cx="9577388" cy="5965512"/>
        </p:xfrm>
        <a:graphic>
          <a:graphicData uri="http://schemas.openxmlformats.org/drawingml/2006/table">
            <a:tbl>
              <a:tblPr/>
              <a:tblGrid>
                <a:gridCol w="1593850"/>
                <a:gridCol w="1593850"/>
                <a:gridCol w="1595438"/>
                <a:gridCol w="1409700"/>
                <a:gridCol w="1778000"/>
                <a:gridCol w="1606550"/>
              </a:tblGrid>
              <a:tr h="338138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Chromosomal band</a:t>
                      </a:r>
                      <a:endParaRPr kumimoji="1" lang="ja-JP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Position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Genomic size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(approximate Mb)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Candidate Genes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4381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Centromeric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Telomeric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Amplified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Truncated/amplified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825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8q22.1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98,425,729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98,846,055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420,327bp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MTDH</a:t>
                      </a: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3’LAPTM4B(tel)</a:t>
                      </a:r>
                      <a:endParaRPr kumimoji="1" lang="ja-JP" altLang="en-US" sz="1200" b="0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984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8q22.2-22.3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01,262,797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01,701,546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438,750bp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RNF19A, ANKRD46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SNX31</a:t>
                      </a: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endParaRPr kumimoji="1" lang="ja-JP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825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8q23.3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16,880,520</a:t>
                      </a:r>
                      <a:endParaRPr kumimoji="1" lang="ja-JP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17,189,301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308,782bp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endParaRPr kumimoji="1" lang="ja-JP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endParaRPr kumimoji="1" lang="ja-JP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825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8q24.11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18,306,187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18,581,694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275,508bp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MED30</a:t>
                      </a:r>
                      <a:endParaRPr kumimoji="1" lang="ja-JP" altLang="en-US" sz="1200" b="0" i="1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endParaRPr kumimoji="1" lang="ja-JP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825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8q24.12-24.13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22,474,513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22,506,564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32,052bp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endParaRPr kumimoji="1" lang="ja-JP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endParaRPr kumimoji="1" lang="ja-JP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825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8q24.13</a:t>
                      </a: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26,158,582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26,545,561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386,980bp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TRIB1</a:t>
                      </a: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3’NSMCE2</a:t>
                      </a: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</a:tr>
              <a:tr h="3825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8q24.13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26,897,599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26,997,319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99,721bp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endParaRPr kumimoji="1" lang="ja-JP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endParaRPr kumimoji="1" lang="ja-JP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476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8q24.21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28,750,329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28,959,443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209,115bp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MYC</a:t>
                      </a:r>
                      <a:endParaRPr kumimoji="1" lang="ja-JP" altLang="en-US" sz="1200" b="0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5’ PVT1</a:t>
                      </a:r>
                      <a:endParaRPr kumimoji="1" lang="ja-JP" altLang="en-US" sz="1200" b="0" i="1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8q24.21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29,862,457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30,266,830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404,374bp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endParaRPr kumimoji="1" lang="ja-JP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825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8q24.21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30,500,292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30,917,357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417,066bp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GSDMC</a:t>
                      </a:r>
                      <a:endParaRPr kumimoji="1" lang="ja-JP" altLang="en-US" sz="1200" b="0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5’CCDC26</a:t>
                      </a:r>
                      <a:endParaRPr kumimoji="1" lang="ja-JP" altLang="en-US" sz="1200" b="0" i="1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3’FAM49B</a:t>
                      </a:r>
                      <a:endParaRPr kumimoji="1" lang="ja-JP" altLang="en-US" sz="1200" b="0" i="1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195"/>
                      </a:srgbClr>
                    </a:solidFill>
                  </a:tcPr>
                </a:tc>
              </a:tr>
              <a:tr h="4762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8q24.22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33,053,164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33,291,464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238,301bp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endParaRPr kumimoji="1" lang="en-US" altLang="ja-JP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5’OC90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3’KCNQ3</a:t>
                      </a:r>
                      <a:endParaRPr kumimoji="1" lang="ja-JP" altLang="en-US" sz="1200" b="0" i="1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06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8q24.22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33,661,134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34,160,784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499,651bp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TMEM71, PHF20L1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TG, SLA</a:t>
                      </a: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j-lt"/>
                          <a:ea typeface="ＭＳ Ｐゴシック" charset="0"/>
                          <a:cs typeface="ＭＳ Ｐゴシック" charset="0"/>
                        </a:rPr>
                        <a:t>5’LRRC6</a:t>
                      </a: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825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8q24.23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38,257,593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38,367,419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ＭＳ Ｐゴシック" charset="0"/>
                        </a:rPr>
                        <a:t>109,827bp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endParaRPr kumimoji="1" lang="ja-JP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j-lt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02870" marR="10287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36285" name="テキスト ボックス 2"/>
          <p:cNvSpPr txBox="1">
            <a:spLocks noChangeArrowheads="1"/>
          </p:cNvSpPr>
          <p:nvPr/>
        </p:nvSpPr>
        <p:spPr bwMode="auto">
          <a:xfrm>
            <a:off x="0" y="44450"/>
            <a:ext cx="298326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 dirty="0" smtClean="0"/>
              <a:t>Supplementary </a:t>
            </a:r>
            <a:r>
              <a:rPr lang="en-US" altLang="ja-JP" sz="1600" b="1" smtClean="0"/>
              <a:t>Table </a:t>
            </a:r>
            <a:r>
              <a:rPr lang="en-US" altLang="ja-JP" sz="1600" b="1" smtClean="0"/>
              <a:t>S1</a:t>
            </a:r>
            <a:endParaRPr lang="ja-JP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35301868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281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50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281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50" charset="-128"/>
          </a:defRPr>
        </a:defPPr>
      </a:lstStyle>
    </a:lnDef>
  </a:objectDefaults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59</TotalTime>
  <Words>111</Words>
  <Application>Microsoft Office PowerPoint</Application>
  <PresentationFormat>35mm スライド</PresentationFormat>
  <Paragraphs>93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標準デザイ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谷脇</dc:creator>
  <cp:lastModifiedBy>Windows ユーザー</cp:lastModifiedBy>
  <cp:revision>362</cp:revision>
  <cp:lastPrinted>2014-03-13T03:03:14Z</cp:lastPrinted>
  <dcterms:created xsi:type="dcterms:W3CDTF">2012-11-30T04:34:21Z</dcterms:created>
  <dcterms:modified xsi:type="dcterms:W3CDTF">2014-08-30T07:22:56Z</dcterms:modified>
</cp:coreProperties>
</file>